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594" autoAdjust="0"/>
  </p:normalViewPr>
  <p:slideViewPr>
    <p:cSldViewPr snapToGrid="0" snapToObjects="1">
      <p:cViewPr>
        <p:scale>
          <a:sx n="289" d="100"/>
          <a:sy n="289" d="100"/>
        </p:scale>
        <p:origin x="440" y="142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Desktop:recommentsandsnpcorrectedsupplementaryimages:SSR_Categorizationafterreview.B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519592975602"/>
          <c:y val="0.0352777777777778"/>
          <c:w val="0.840501669279825"/>
          <c:h val="0.5742192536561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</c:spPr>
          <c:invertIfNegative val="0"/>
          <c:cat>
            <c:strRef>
              <c:f>Sheet2!$D$8:$D$12</c:f>
              <c:strCache>
                <c:ptCount val="5"/>
                <c:pt idx="0">
                  <c:v>Transcription</c:v>
                </c:pt>
                <c:pt idx="1">
                  <c:v>Developmental Process</c:v>
                </c:pt>
                <c:pt idx="2">
                  <c:v>Multicellular Organismal Development</c:v>
                </c:pt>
                <c:pt idx="3">
                  <c:v>Macromolecule Biosynthetic Process</c:v>
                </c:pt>
                <c:pt idx="4">
                  <c:v>Cellular Macromolecule Biosynthetic Process</c:v>
                </c:pt>
              </c:strCache>
            </c:strRef>
          </c:cat>
          <c:val>
            <c:numRef>
              <c:f>Sheet2!$E$8:$E$12</c:f>
              <c:numCache>
                <c:formatCode>General</c:formatCode>
                <c:ptCount val="5"/>
                <c:pt idx="0">
                  <c:v>1301.0</c:v>
                </c:pt>
                <c:pt idx="1">
                  <c:v>1913.0</c:v>
                </c:pt>
                <c:pt idx="2">
                  <c:v>1828.0</c:v>
                </c:pt>
                <c:pt idx="3">
                  <c:v>1465.0</c:v>
                </c:pt>
                <c:pt idx="4">
                  <c:v>1465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6388728"/>
        <c:axId val="2088713080"/>
      </c:barChart>
      <c:catAx>
        <c:axId val="2096388728"/>
        <c:scaling>
          <c:orientation val="minMax"/>
        </c:scaling>
        <c:delete val="0"/>
        <c:axPos val="b"/>
        <c:majorTickMark val="out"/>
        <c:minorTickMark val="none"/>
        <c:tickLblPos val="nextTo"/>
        <c:crossAx val="2088713080"/>
        <c:crosses val="autoZero"/>
        <c:auto val="1"/>
        <c:lblAlgn val="ctr"/>
        <c:lblOffset val="100"/>
        <c:noMultiLvlLbl val="0"/>
      </c:catAx>
      <c:valAx>
        <c:axId val="2088713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6388728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6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486593879022"/>
          <c:y val="0.0293981481481481"/>
          <c:w val="0.818115136993278"/>
          <c:h val="0.56005489986765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</c:spPr>
          <c:invertIfNegative val="0"/>
          <c:cat>
            <c:strRef>
              <c:f>Sheet2!$D$14:$D$18</c:f>
              <c:strCache>
                <c:ptCount val="5"/>
                <c:pt idx="0">
                  <c:v>Nucleoplasm</c:v>
                </c:pt>
                <c:pt idx="1">
                  <c:v>Nuclear Part</c:v>
                </c:pt>
                <c:pt idx="2">
                  <c:v>Organelle Lumen</c:v>
                </c:pt>
                <c:pt idx="3">
                  <c:v>Membrane-Enclosed Lumen</c:v>
                </c:pt>
                <c:pt idx="4">
                  <c:v>Intracellular Organelle Lumen</c:v>
                </c:pt>
              </c:strCache>
            </c:strRef>
          </c:cat>
          <c:val>
            <c:numRef>
              <c:f>Sheet2!$E$14:$E$18</c:f>
              <c:numCache>
                <c:formatCode>General</c:formatCode>
                <c:ptCount val="5"/>
                <c:pt idx="0">
                  <c:v>794.0</c:v>
                </c:pt>
                <c:pt idx="1">
                  <c:v>1007.0</c:v>
                </c:pt>
                <c:pt idx="2">
                  <c:v>931.0</c:v>
                </c:pt>
                <c:pt idx="3">
                  <c:v>931.0</c:v>
                </c:pt>
                <c:pt idx="4">
                  <c:v>93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774040"/>
        <c:axId val="2097059512"/>
      </c:barChart>
      <c:catAx>
        <c:axId val="2092774040"/>
        <c:scaling>
          <c:orientation val="minMax"/>
        </c:scaling>
        <c:delete val="0"/>
        <c:axPos val="b"/>
        <c:majorTickMark val="out"/>
        <c:minorTickMark val="none"/>
        <c:tickLblPos val="nextTo"/>
        <c:crossAx val="2097059512"/>
        <c:crosses val="autoZero"/>
        <c:auto val="1"/>
        <c:lblAlgn val="ctr"/>
        <c:lblOffset val="100"/>
        <c:noMultiLvlLbl val="0"/>
      </c:catAx>
      <c:valAx>
        <c:axId val="2097059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2774040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6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621759259259"/>
          <c:y val="0.0352777777777778"/>
          <c:w val="0.788220833333333"/>
          <c:h val="0.5509106481481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</c:spPr>
          <c:invertIfNegative val="0"/>
          <c:cat>
            <c:strRef>
              <c:f>Sheet2!$D$25:$D$29</c:f>
              <c:strCache>
                <c:ptCount val="5"/>
                <c:pt idx="0">
                  <c:v>DNA Binding</c:v>
                </c:pt>
                <c:pt idx="1">
                  <c:v>Protein Binding</c:v>
                </c:pt>
                <c:pt idx="2">
                  <c:v>GTPase Activity</c:v>
                </c:pt>
                <c:pt idx="3">
                  <c:v>Translation Factor Activity</c:v>
                </c:pt>
                <c:pt idx="4">
                  <c:v>Histone Binding</c:v>
                </c:pt>
              </c:strCache>
            </c:strRef>
          </c:cat>
          <c:val>
            <c:numRef>
              <c:f>Sheet2!$E$25:$E$29</c:f>
              <c:numCache>
                <c:formatCode>General</c:formatCode>
                <c:ptCount val="5"/>
                <c:pt idx="0">
                  <c:v>967.0</c:v>
                </c:pt>
                <c:pt idx="1">
                  <c:v>329.0</c:v>
                </c:pt>
                <c:pt idx="2">
                  <c:v>84.0</c:v>
                </c:pt>
                <c:pt idx="3">
                  <c:v>108.0</c:v>
                </c:pt>
                <c:pt idx="4">
                  <c:v>28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7101048"/>
        <c:axId val="2097082024"/>
      </c:barChart>
      <c:catAx>
        <c:axId val="2097101048"/>
        <c:scaling>
          <c:orientation val="minMax"/>
        </c:scaling>
        <c:delete val="0"/>
        <c:axPos val="b"/>
        <c:majorTickMark val="out"/>
        <c:minorTickMark val="none"/>
        <c:tickLblPos val="nextTo"/>
        <c:crossAx val="2097082024"/>
        <c:crosses val="autoZero"/>
        <c:auto val="1"/>
        <c:lblAlgn val="ctr"/>
        <c:lblOffset val="100"/>
        <c:noMultiLvlLbl val="0"/>
      </c:catAx>
      <c:valAx>
        <c:axId val="2097082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7101048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6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621759259259"/>
          <c:y val="0.0352777777777778"/>
          <c:w val="0.794100462962963"/>
          <c:h val="0.6551777777777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504D"/>
            </a:solidFill>
          </c:spPr>
          <c:invertIfNegative val="0"/>
          <c:cat>
            <c:strRef>
              <c:f>Sheet2!$D$37:$D$41</c:f>
              <c:strCache>
                <c:ptCount val="5"/>
                <c:pt idx="0">
                  <c:v>Nucleus</c:v>
                </c:pt>
                <c:pt idx="1">
                  <c:v>Cell</c:v>
                </c:pt>
                <c:pt idx="2">
                  <c:v>Cell Part</c:v>
                </c:pt>
                <c:pt idx="3">
                  <c:v>Intracellular</c:v>
                </c:pt>
                <c:pt idx="4">
                  <c:v>Intracellular Part</c:v>
                </c:pt>
              </c:strCache>
            </c:strRef>
          </c:cat>
          <c:val>
            <c:numRef>
              <c:f>Sheet2!$E$37:$E$41</c:f>
              <c:numCache>
                <c:formatCode>General</c:formatCode>
                <c:ptCount val="5"/>
                <c:pt idx="0">
                  <c:v>2410.0</c:v>
                </c:pt>
                <c:pt idx="1">
                  <c:v>5952.0</c:v>
                </c:pt>
                <c:pt idx="2">
                  <c:v>5939.0</c:v>
                </c:pt>
                <c:pt idx="3">
                  <c:v>5665.0</c:v>
                </c:pt>
                <c:pt idx="4">
                  <c:v>5505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8718216"/>
        <c:axId val="2088604680"/>
      </c:barChart>
      <c:catAx>
        <c:axId val="2088718216"/>
        <c:scaling>
          <c:orientation val="minMax"/>
        </c:scaling>
        <c:delete val="0"/>
        <c:axPos val="b"/>
        <c:majorTickMark val="out"/>
        <c:minorTickMark val="none"/>
        <c:tickLblPos val="nextTo"/>
        <c:crossAx val="2088604680"/>
        <c:crosses val="autoZero"/>
        <c:auto val="1"/>
        <c:lblAlgn val="ctr"/>
        <c:lblOffset val="100"/>
        <c:noMultiLvlLbl val="0"/>
      </c:catAx>
      <c:valAx>
        <c:axId val="2088604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88718216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6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387914694109"/>
          <c:y val="0.0411574074074074"/>
          <c:w val="0.769620646536096"/>
          <c:h val="0.583829629629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504D"/>
            </a:solidFill>
          </c:spPr>
          <c:invertIfNegative val="0"/>
          <c:cat>
            <c:strRef>
              <c:f>Sheet2!$D$31:$D$35</c:f>
              <c:strCache>
                <c:ptCount val="5"/>
                <c:pt idx="0">
                  <c:v>Anatomical Structure Development</c:v>
                </c:pt>
                <c:pt idx="1">
                  <c:v>Developmental Process</c:v>
                </c:pt>
                <c:pt idx="2">
                  <c:v>Cellular Component Organization</c:v>
                </c:pt>
                <c:pt idx="3">
                  <c:v>Reproduction</c:v>
                </c:pt>
                <c:pt idx="4">
                  <c:v>Cell Cycle</c:v>
                </c:pt>
              </c:strCache>
            </c:strRef>
          </c:cat>
          <c:val>
            <c:numRef>
              <c:f>Sheet2!$E$31:$E$35</c:f>
              <c:numCache>
                <c:formatCode>General</c:formatCode>
                <c:ptCount val="5"/>
                <c:pt idx="0">
                  <c:v>1638.0</c:v>
                </c:pt>
                <c:pt idx="1">
                  <c:v>1814.0</c:v>
                </c:pt>
                <c:pt idx="2">
                  <c:v>1419.0</c:v>
                </c:pt>
                <c:pt idx="3">
                  <c:v>1260.0</c:v>
                </c:pt>
                <c:pt idx="4">
                  <c:v>564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3283592"/>
        <c:axId val="2083160312"/>
      </c:barChart>
      <c:catAx>
        <c:axId val="20832835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83160312"/>
        <c:crosses val="autoZero"/>
        <c:auto val="1"/>
        <c:lblAlgn val="ctr"/>
        <c:lblOffset val="100"/>
        <c:noMultiLvlLbl val="0"/>
      </c:catAx>
      <c:valAx>
        <c:axId val="2083160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83283592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7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7202419133144"/>
          <c:y val="0.0271034528803759"/>
          <c:w val="0.662699622799098"/>
          <c:h val="0.4754976331463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</c:spPr>
          <c:invertIfNegative val="0"/>
          <c:cat>
            <c:strRef>
              <c:f>Sheet2!$D$2:$D$6</c:f>
              <c:strCache>
                <c:ptCount val="5"/>
                <c:pt idx="0">
                  <c:v>Transcription Regulator Activity</c:v>
                </c:pt>
                <c:pt idx="1">
                  <c:v>Transcription Factor Activity</c:v>
                </c:pt>
                <c:pt idx="2">
                  <c:v>DNA Binding</c:v>
                </c:pt>
                <c:pt idx="3">
                  <c:v>Protein Binding</c:v>
                </c:pt>
                <c:pt idx="4">
                  <c:v>Translation Factor Activity, Nucleic Acid Binding</c:v>
                </c:pt>
              </c:strCache>
            </c:strRef>
          </c:cat>
          <c:val>
            <c:numRef>
              <c:f>Sheet2!$E$2:$E$6</c:f>
              <c:numCache>
                <c:formatCode>General</c:formatCode>
                <c:ptCount val="5"/>
                <c:pt idx="0">
                  <c:v>669.0</c:v>
                </c:pt>
                <c:pt idx="1">
                  <c:v>621.0</c:v>
                </c:pt>
                <c:pt idx="2">
                  <c:v>1164.0</c:v>
                </c:pt>
                <c:pt idx="3">
                  <c:v>1118.0</c:v>
                </c:pt>
                <c:pt idx="4">
                  <c:v>10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288392"/>
        <c:axId val="2078538392"/>
      </c:barChart>
      <c:catAx>
        <c:axId val="20922883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78538392"/>
        <c:crosses val="autoZero"/>
        <c:auto val="1"/>
        <c:lblAlgn val="ctr"/>
        <c:lblOffset val="100"/>
        <c:noMultiLvlLbl val="0"/>
      </c:catAx>
      <c:valAx>
        <c:axId val="2078538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92288392"/>
        <c:crosses val="autoZero"/>
        <c:crossBetween val="between"/>
      </c:valAx>
      <c:spPr>
        <a:solidFill>
          <a:srgbClr val="F2F2F2"/>
        </a:solidFill>
      </c:spPr>
    </c:plotArea>
    <c:plotVisOnly val="1"/>
    <c:dispBlanksAs val="gap"/>
    <c:showDLblsOverMax val="0"/>
  </c:chart>
  <c:txPr>
    <a:bodyPr/>
    <a:lstStyle/>
    <a:p>
      <a:pPr>
        <a:defRPr sz="7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555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062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667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844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70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174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709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130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66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438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557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BA413C-416D-EB48-9A7A-2FD0565BAD82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34424-EF86-3F40-B74D-65BAE701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91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761175" y="1233530"/>
            <a:ext cx="4977965" cy="7506137"/>
            <a:chOff x="761175" y="1233530"/>
            <a:chExt cx="4977965" cy="7506137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1228435"/>
                </p:ext>
              </p:extLst>
            </p:nvPr>
          </p:nvGraphicFramePr>
          <p:xfrm>
            <a:off x="1301291" y="3963027"/>
            <a:ext cx="2100906" cy="20475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90202321"/>
                </p:ext>
              </p:extLst>
            </p:nvPr>
          </p:nvGraphicFramePr>
          <p:xfrm>
            <a:off x="1301291" y="6046059"/>
            <a:ext cx="2100906" cy="25704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74816118"/>
                </p:ext>
              </p:extLst>
            </p:nvPr>
          </p:nvGraphicFramePr>
          <p:xfrm>
            <a:off x="3539764" y="3963027"/>
            <a:ext cx="21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7103030"/>
                </p:ext>
              </p:extLst>
            </p:nvPr>
          </p:nvGraphicFramePr>
          <p:xfrm>
            <a:off x="3539764" y="6043675"/>
            <a:ext cx="21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71147853"/>
                </p:ext>
              </p:extLst>
            </p:nvPr>
          </p:nvGraphicFramePr>
          <p:xfrm>
            <a:off x="3402197" y="1402624"/>
            <a:ext cx="2297567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7508447"/>
                </p:ext>
              </p:extLst>
            </p:nvPr>
          </p:nvGraphicFramePr>
          <p:xfrm>
            <a:off x="761175" y="1402624"/>
            <a:ext cx="2662772" cy="27109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2537261" y="8493446"/>
              <a:ext cx="254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dirty="0" smtClean="0">
                  <a:latin typeface="Arial"/>
                  <a:cs typeface="Arial"/>
                </a:rPr>
                <a:t>Supporting </a:t>
              </a:r>
              <a:r>
                <a:rPr lang="en-US" sz="1000" smtClean="0">
                  <a:latin typeface="Arial"/>
                  <a:cs typeface="Arial"/>
                </a:rPr>
                <a:t>Figure </a:t>
              </a:r>
              <a:r>
                <a:rPr lang="en-US" sz="1000" smtClean="0">
                  <a:latin typeface="Arial"/>
                  <a:cs typeface="Arial"/>
                </a:rPr>
                <a:t>2.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 rot="16200000">
              <a:off x="489654" y="2062976"/>
              <a:ext cx="12324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ological Process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71846" y="4498231"/>
              <a:ext cx="12680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smtClean="0">
                  <a:latin typeface="Arial"/>
                  <a:cs typeface="Arial"/>
                </a:rPr>
                <a:t>Molecular Function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389937" y="6790569"/>
              <a:ext cx="14318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smtClean="0">
                  <a:latin typeface="Arial"/>
                  <a:cs typeface="Arial"/>
                </a:rPr>
                <a:t>Cellular Compartment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14675" y="1234544"/>
              <a:ext cx="11198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i="1" dirty="0" err="1" smtClean="0">
                  <a:latin typeface="Arial"/>
                  <a:cs typeface="Arial"/>
                </a:rPr>
                <a:t>Morus</a:t>
              </a:r>
              <a:r>
                <a:rPr lang="en-US" sz="1000" i="1" dirty="0" smtClean="0">
                  <a:latin typeface="Arial"/>
                  <a:cs typeface="Arial"/>
                </a:rPr>
                <a:t> </a:t>
              </a:r>
              <a:r>
                <a:rPr lang="en-US" sz="1000" i="1" dirty="0" err="1">
                  <a:latin typeface="Arial"/>
                  <a:cs typeface="Arial"/>
                </a:rPr>
                <a:t>l</a:t>
              </a:r>
              <a:r>
                <a:rPr lang="en-US" sz="1000" i="1" dirty="0" err="1" smtClean="0">
                  <a:latin typeface="Arial"/>
                  <a:cs typeface="Arial"/>
                </a:rPr>
                <a:t>aevigata</a:t>
              </a:r>
              <a:endParaRPr lang="en-US" sz="1000" i="1" dirty="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33507" y="1233530"/>
              <a:ext cx="10056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i="1" dirty="0" err="1" smtClean="0">
                  <a:latin typeface="Arial"/>
                  <a:cs typeface="Arial"/>
                </a:rPr>
                <a:t>Morus</a:t>
              </a:r>
              <a:r>
                <a:rPr lang="en-US" sz="1000" i="1" dirty="0" smtClean="0">
                  <a:latin typeface="Arial"/>
                  <a:cs typeface="Arial"/>
                </a:rPr>
                <a:t> </a:t>
              </a:r>
              <a:r>
                <a:rPr lang="en-US" sz="1000" i="1" dirty="0" err="1" smtClean="0">
                  <a:latin typeface="Arial"/>
                  <a:cs typeface="Arial"/>
                </a:rPr>
                <a:t>serrata</a:t>
              </a:r>
              <a:endParaRPr lang="en-US" sz="1000" i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59384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4</Words>
  <Application>Microsoft Macintosh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hra</dc:creator>
  <cp:lastModifiedBy>Bushra</cp:lastModifiedBy>
  <cp:revision>12</cp:revision>
  <dcterms:created xsi:type="dcterms:W3CDTF">2015-10-24T15:00:56Z</dcterms:created>
  <dcterms:modified xsi:type="dcterms:W3CDTF">2015-10-28T07:19:05Z</dcterms:modified>
</cp:coreProperties>
</file>